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8" r:id="rId3"/>
    <p:sldId id="257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E5C8043-1747-4313-998C-F1A82838CD52}" v="41" dt="2022-08-26T13:26:16.3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13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microsoft.com/office/2015/10/relationships/revisionInfo" Target="revisionInfo.xml"/><Relationship Id="rId4" Type="http://schemas.openxmlformats.org/officeDocument/2006/relationships/slide" Target="slides/slide2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EU!$B$1</c:f>
              <c:strCache>
                <c:ptCount val="1"/>
                <c:pt idx="0">
                  <c:v>Very low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EU!$A$2:$A$7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EU!$B$2:$B$7</c:f>
              <c:numCache>
                <c:formatCode>0.00%</c:formatCode>
                <c:ptCount val="6"/>
                <c:pt idx="0">
                  <c:v>0.14299999999999999</c:v>
                </c:pt>
                <c:pt idx="1">
                  <c:v>6.0999999999999999E-2</c:v>
                </c:pt>
                <c:pt idx="2">
                  <c:v>0.02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26-4ECF-BDF5-4737953F331A}"/>
            </c:ext>
          </c:extLst>
        </c:ser>
        <c:ser>
          <c:idx val="1"/>
          <c:order val="1"/>
          <c:tx>
            <c:strRef>
              <c:f>EU!$C$1</c:f>
              <c:strCache>
                <c:ptCount val="1"/>
                <c:pt idx="0">
                  <c:v>Low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EU!$A$2:$A$7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EU!$C$2:$C$7</c:f>
              <c:numCache>
                <c:formatCode>0.00%</c:formatCode>
                <c:ptCount val="6"/>
                <c:pt idx="0">
                  <c:v>0.34699999999999998</c:v>
                </c:pt>
                <c:pt idx="1">
                  <c:v>0.224</c:v>
                </c:pt>
                <c:pt idx="2">
                  <c:v>0.14299999999999999</c:v>
                </c:pt>
                <c:pt idx="3">
                  <c:v>4.1000000000000002E-2</c:v>
                </c:pt>
                <c:pt idx="4">
                  <c:v>0.0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26-4ECF-BDF5-4737953F331A}"/>
            </c:ext>
          </c:extLst>
        </c:ser>
        <c:ser>
          <c:idx val="2"/>
          <c:order val="2"/>
          <c:tx>
            <c:strRef>
              <c:f>EU!$D$1</c:f>
              <c:strCache>
                <c:ptCount val="1"/>
                <c:pt idx="0">
                  <c:v>Average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EU!$A$2:$A$7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EU!$D$2:$D$7</c:f>
              <c:numCache>
                <c:formatCode>0.00%</c:formatCode>
                <c:ptCount val="6"/>
                <c:pt idx="0">
                  <c:v>0.30599999999999999</c:v>
                </c:pt>
                <c:pt idx="1">
                  <c:v>0.32700000000000001</c:v>
                </c:pt>
                <c:pt idx="2">
                  <c:v>0.32700000000000001</c:v>
                </c:pt>
                <c:pt idx="3">
                  <c:v>0.20399999999999999</c:v>
                </c:pt>
                <c:pt idx="4">
                  <c:v>0.10199999999999999</c:v>
                </c:pt>
                <c:pt idx="5">
                  <c:v>4.10000000000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726-4ECF-BDF5-4737953F331A}"/>
            </c:ext>
          </c:extLst>
        </c:ser>
        <c:ser>
          <c:idx val="3"/>
          <c:order val="3"/>
          <c:tx>
            <c:strRef>
              <c:f>EU!$E$1</c:f>
              <c:strCache>
                <c:ptCount val="1"/>
                <c:pt idx="0">
                  <c:v>High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EU!$A$2:$A$7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EU!$E$2:$E$7</c:f>
              <c:numCache>
                <c:formatCode>0.00%</c:formatCode>
                <c:ptCount val="6"/>
                <c:pt idx="0">
                  <c:v>0.16300000000000001</c:v>
                </c:pt>
                <c:pt idx="1">
                  <c:v>0.28599999999999998</c:v>
                </c:pt>
                <c:pt idx="2">
                  <c:v>0.42899999999999999</c:v>
                </c:pt>
                <c:pt idx="3">
                  <c:v>0.46899999999999997</c:v>
                </c:pt>
                <c:pt idx="4">
                  <c:v>0.44900000000000001</c:v>
                </c:pt>
                <c:pt idx="5">
                  <c:v>0.305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726-4ECF-BDF5-4737953F331A}"/>
            </c:ext>
          </c:extLst>
        </c:ser>
        <c:ser>
          <c:idx val="4"/>
          <c:order val="4"/>
          <c:tx>
            <c:strRef>
              <c:f>EU!$F$1</c:f>
              <c:strCache>
                <c:ptCount val="1"/>
                <c:pt idx="0">
                  <c:v>Very high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EU!$A$2:$A$7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EU!$F$2:$F$7</c:f>
              <c:numCache>
                <c:formatCode>0.00%</c:formatCode>
                <c:ptCount val="6"/>
                <c:pt idx="0">
                  <c:v>4.1000000000000002E-2</c:v>
                </c:pt>
                <c:pt idx="1">
                  <c:v>0.10199999999999999</c:v>
                </c:pt>
                <c:pt idx="2">
                  <c:v>8.2000000000000003E-2</c:v>
                </c:pt>
                <c:pt idx="3">
                  <c:v>0.28599999999999998</c:v>
                </c:pt>
                <c:pt idx="4">
                  <c:v>0.42899999999999999</c:v>
                </c:pt>
                <c:pt idx="5">
                  <c:v>0.653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726-4ECF-BDF5-4737953F33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9558096"/>
        <c:axId val="389554816"/>
      </c:barChart>
      <c:catAx>
        <c:axId val="3895580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389554816"/>
        <c:crosses val="autoZero"/>
        <c:auto val="1"/>
        <c:lblAlgn val="ctr"/>
        <c:lblOffset val="100"/>
        <c:noMultiLvlLbl val="0"/>
      </c:catAx>
      <c:valAx>
        <c:axId val="389554816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389558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US!$B$2</c:f>
              <c:strCache>
                <c:ptCount val="1"/>
                <c:pt idx="0">
                  <c:v>Very low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US!$A$3:$A$8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US!$B$3:$B$8</c:f>
              <c:numCache>
                <c:formatCode>0.00%</c:formatCode>
                <c:ptCount val="6"/>
                <c:pt idx="0">
                  <c:v>3.7999999999999999E-2</c:v>
                </c:pt>
                <c:pt idx="1">
                  <c:v>0</c:v>
                </c:pt>
                <c:pt idx="2">
                  <c:v>3.7999999999999999E-2</c:v>
                </c:pt>
                <c:pt idx="3">
                  <c:v>0</c:v>
                </c:pt>
                <c:pt idx="4">
                  <c:v>3.7999999999999999E-2</c:v>
                </c:pt>
                <c:pt idx="5">
                  <c:v>7.6999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75-47C8-BBE9-ED089954FDC8}"/>
            </c:ext>
          </c:extLst>
        </c:ser>
        <c:ser>
          <c:idx val="1"/>
          <c:order val="1"/>
          <c:tx>
            <c:strRef>
              <c:f>US!$C$2</c:f>
              <c:strCache>
                <c:ptCount val="1"/>
                <c:pt idx="0">
                  <c:v>Low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US!$A$3:$A$8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US!$C$3:$C$8</c:f>
              <c:numCache>
                <c:formatCode>0.00%</c:formatCode>
                <c:ptCount val="6"/>
                <c:pt idx="0">
                  <c:v>0.42299999999999999</c:v>
                </c:pt>
                <c:pt idx="1">
                  <c:v>0.115</c:v>
                </c:pt>
                <c:pt idx="2">
                  <c:v>0</c:v>
                </c:pt>
                <c:pt idx="3">
                  <c:v>0.115</c:v>
                </c:pt>
                <c:pt idx="4">
                  <c:v>7.6999999999999999E-2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75-47C8-BBE9-ED089954FDC8}"/>
            </c:ext>
          </c:extLst>
        </c:ser>
        <c:ser>
          <c:idx val="2"/>
          <c:order val="2"/>
          <c:tx>
            <c:strRef>
              <c:f>US!$D$2</c:f>
              <c:strCache>
                <c:ptCount val="1"/>
                <c:pt idx="0">
                  <c:v>Average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US!$A$3:$A$8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US!$D$3:$D$8</c:f>
              <c:numCache>
                <c:formatCode>0.00%</c:formatCode>
                <c:ptCount val="6"/>
                <c:pt idx="0">
                  <c:v>0.34599999999999997</c:v>
                </c:pt>
                <c:pt idx="1">
                  <c:v>0.23100000000000001</c:v>
                </c:pt>
                <c:pt idx="2">
                  <c:v>0.42299999999999999</c:v>
                </c:pt>
                <c:pt idx="3">
                  <c:v>0.115</c:v>
                </c:pt>
                <c:pt idx="4">
                  <c:v>7.6999999999999999E-2</c:v>
                </c:pt>
                <c:pt idx="5">
                  <c:v>7.6999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875-47C8-BBE9-ED089954FDC8}"/>
            </c:ext>
          </c:extLst>
        </c:ser>
        <c:ser>
          <c:idx val="3"/>
          <c:order val="3"/>
          <c:tx>
            <c:strRef>
              <c:f>US!$E$2</c:f>
              <c:strCache>
                <c:ptCount val="1"/>
                <c:pt idx="0">
                  <c:v>High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cat>
            <c:strRef>
              <c:f>US!$A$3:$A$8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US!$E$3:$E$8</c:f>
              <c:numCache>
                <c:formatCode>0.00%</c:formatCode>
                <c:ptCount val="6"/>
                <c:pt idx="0">
                  <c:v>0.154</c:v>
                </c:pt>
                <c:pt idx="1">
                  <c:v>0.46200000000000002</c:v>
                </c:pt>
                <c:pt idx="2">
                  <c:v>0.5</c:v>
                </c:pt>
                <c:pt idx="3">
                  <c:v>0.65400000000000003</c:v>
                </c:pt>
                <c:pt idx="4">
                  <c:v>0.57699999999999996</c:v>
                </c:pt>
                <c:pt idx="5">
                  <c:v>0.422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875-47C8-BBE9-ED089954FDC8}"/>
            </c:ext>
          </c:extLst>
        </c:ser>
        <c:ser>
          <c:idx val="4"/>
          <c:order val="4"/>
          <c:tx>
            <c:strRef>
              <c:f>US!$F$2</c:f>
              <c:strCache>
                <c:ptCount val="1"/>
                <c:pt idx="0">
                  <c:v>Very high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US!$A$3:$A$8</c:f>
              <c:strCache>
                <c:ptCount val="6"/>
                <c:pt idx="0">
                  <c:v>PK &amp; PD data and safety data from phase I</c:v>
                </c:pt>
                <c:pt idx="1">
                  <c:v>Mode of action specific to the disease/therapeutic area</c:v>
                </c:pt>
                <c:pt idx="2">
                  <c:v>Combined safety data from pre-clinical, phase I and II studies</c:v>
                </c:pt>
                <c:pt idx="3">
                  <c:v>Clinical efficacy data over alternative treatment</c:v>
                </c:pt>
                <c:pt idx="4">
                  <c:v>Safety data from phase II/III</c:v>
                </c:pt>
                <c:pt idx="5">
                  <c:v>Clinical efficacy data from the phase III randomized controlled trial over placebo/available standard of care</c:v>
                </c:pt>
              </c:strCache>
            </c:strRef>
          </c:cat>
          <c:val>
            <c:numRef>
              <c:f>US!$F$3:$F$8</c:f>
              <c:numCache>
                <c:formatCode>0.00%</c:formatCode>
                <c:ptCount val="6"/>
                <c:pt idx="0">
                  <c:v>3.7999999999999999E-2</c:v>
                </c:pt>
                <c:pt idx="1">
                  <c:v>0.192</c:v>
                </c:pt>
                <c:pt idx="2">
                  <c:v>3.7999999999999999E-2</c:v>
                </c:pt>
                <c:pt idx="3">
                  <c:v>0.115</c:v>
                </c:pt>
                <c:pt idx="4">
                  <c:v>0.23100000000000001</c:v>
                </c:pt>
                <c:pt idx="5">
                  <c:v>0.422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875-47C8-BBE9-ED089954FD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06272112"/>
        <c:axId val="606270472"/>
      </c:barChart>
      <c:catAx>
        <c:axId val="6062721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606270472"/>
        <c:crosses val="autoZero"/>
        <c:auto val="1"/>
        <c:lblAlgn val="ctr"/>
        <c:lblOffset val="100"/>
        <c:noMultiLvlLbl val="0"/>
      </c:catAx>
      <c:valAx>
        <c:axId val="606270472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DE"/>
          </a:p>
        </c:txPr>
        <c:crossAx val="6062721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30EEBA-388E-44E3-B1F0-66750EC2FB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B6FF07-2FC7-4A9B-9A48-DBD0489761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99DAD7-CD0C-4C71-AD23-7D2F5AAFB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D87D70-B5A3-4D3E-AAFA-B0DA8B91A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E2E8DB-B0B0-4E39-9EC0-004C76FAA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5442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FBE366-A43D-4D8C-81A9-85871E0522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E85748-32D3-45E6-85AE-460B2D348F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36D355-28E6-4B62-BF00-F31EE1987D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5AB4CB-7990-4834-8995-BB2811415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624DC6-0810-465F-9EC4-B9B951DC3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3303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9E09B9-98B0-4C5B-8CBB-615415D71D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A00DA7-6BE0-4EA2-8107-7116733390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E79ECC-47F1-4447-B37C-1A6C2B15A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5C1339-819A-4F5F-9CEC-0AA70F02B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35BB0F-14F5-4A2F-A704-E4C70FCB3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129504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C60FE9-566C-4D95-9304-401478008E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B49D3B-AFAE-4FCE-86E6-515C541917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70AB1A-BB09-4DC7-9DDA-04302E7CA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BCF127-C4DB-47AB-BABC-216514351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3D5EEE-8411-4306-9019-EA284A8F4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27878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8BC7D-AB0D-4AC7-8EAB-3F0570B71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7DAD68-F6CD-40CB-82D4-7A4B321CA0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374B1B-DABA-419C-8E1D-F3D7E08F69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06877-630B-4658-ADE7-DB4FDB981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7F129F-E00E-46CC-8478-8D53C7973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38461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3A50A8-F3A6-4D3E-B313-DEF6A3E33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8C18B2-6DE4-48E7-8B96-BA8C85D0DE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AD6B4-A94F-4CA4-8654-87F4C420E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CFE9D5-EB32-4A51-97E3-82742131C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E3288-14D7-4252-8841-95697ACD3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80785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263EE-0D6C-4DC3-A033-63FC2D204D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646ADC-CF01-44D7-A32A-3072C858CB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E8946B-EA93-4292-A38C-70E4F6CE4A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D3A1F2-89B8-40B9-9913-9E51C30A8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29439B-99D1-496F-BA97-A1A470C3C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B852E6-4557-48B1-9344-A4176A518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51980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7DF59-D8DB-42C7-9D6D-2324E6B5FC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B04F8E-912B-4644-AE6E-778AD09319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5C88E0-8A64-4157-9CCC-326B324E2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251E89-7B6C-4909-9013-52E8E27B99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9C570-FBD9-48AA-8844-03861D1947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6DF997-366A-4433-A0B3-3F4A70B0F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787223-6F68-4D82-99E5-9B93456BA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457904-6528-4962-8799-D344B9811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1006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99DAA-8BB5-418A-8DD7-92FA9FAF01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9FB9E9-7F97-4014-AC6F-D5C409C02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6C7FF6-5BB4-491F-ABDB-F79F5567D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86CF20-280E-4CF1-8E34-BDCCC0FA9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83649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CD37C83-1465-40FA-B60C-5A757A629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49D5DF-A388-42DF-AAC6-50E873BAFE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24C439-7602-4E6C-93D8-AB9C9AC95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1147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AF85D-A3C7-40C0-AE79-2658B0501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5D882E-166A-4741-8CAB-8B87F8601F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9B494D-1B4C-4B7C-81C2-ED69154AC3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4E7A9F-92AF-4AA5-91D8-0D990E1CD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AD82ED-ABBD-4ECA-B66B-92A2A0102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2807BD-04BF-4C15-8702-78A0498A4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910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9F0928-E7C7-4A64-978C-B44B292B6E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7664F4-1B1E-47B7-A408-12C11513B2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87856E-FE89-4B8B-BC2D-B21918EB0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5E37D7-C1DF-4C77-B137-62818FE93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1F0316-C882-4CC0-8935-34560B5E2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529696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B39FC-52B2-43AF-BFD4-2BC6A58672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A64028-D7E6-40DE-9DB2-4C6B805434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7A8C7E-5AD9-44E8-9FA9-0A142B11A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64AE9D-6A51-4461-8D4B-182B72DE9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0B7836-440A-479A-AA19-4F6F8F216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F1617F-18C7-43B7-97CF-CD2D91726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26687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4A676-CB94-4DDF-B349-59436C5E4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21B5BC-5FB7-460D-B6C3-97897F7645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F0FAD-8A9C-4797-9712-ADC028C0A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DA043F-45C6-402B-B8E0-B8D1240E2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D84154-F9ED-41F8-A5C9-D1ED30449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02157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6BDB66-BEA0-401C-BCA1-AF456A971E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237161-9F41-4DC9-B35F-EBC2C1279E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6CB68E-250A-463A-AE06-4D42E146B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A8C4BF-BC95-40D3-95EA-0AB576787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F6091E-421F-462F-84F1-33ECF01C0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059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D4DBA4-57F0-48C6-B984-5243EC48E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B9855C-3438-42A2-ACD0-A789D9002F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1F5FBA-1C14-43E1-87F1-A59FDE5B15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513A2D-C5CC-4940-8124-63548B825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2D19B4-3BA8-4906-ABDA-1DA48A2C5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9903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2C99A1-0C8D-45E2-A67B-404404159D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DC2DB4-CDF7-4894-813E-DB3D39964C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0632E6-E3E6-4539-91E2-EAAB196CAF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A29F0C-E799-43DF-9A7D-6411C4936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614569-8912-471F-843C-C5EE4831F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0DE927-6A0D-49FD-BD3D-EB3E9DA08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8299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727ED9-F642-40F3-AD36-98F576A52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BEF97-816E-4F35-AE5A-0F67FE9EA9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FCD3CC-6B42-4142-9E59-62F0F1DDB4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38229C-1667-40B7-A33B-BFEB2DF858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42CCBE-EA6B-4013-852E-8305774CFA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A8E4C8E-6899-4DA9-B458-C3E17D68D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FFAD70-ACF0-402F-81D3-0222DB742D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42344B-2299-4F92-8413-CD0C9FEDB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036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4941F8-EA90-4D19-91A0-20BE0E3D77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2070B8-35CC-4629-8647-AC082D6AF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271B91-AF79-4083-9FD4-D95F21B07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5D36E0-F210-458D-B0A6-0A7006B85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053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407EAD-C0AF-443F-9C40-1B51176DD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EA1944-DC1F-42A8-8870-BC05844C7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8E48E4-676F-4C6E-A668-76E75D449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3488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34731-069B-4D2E-86CC-46B8E10C0D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078011-6F15-4BB0-99B4-36A961F829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57CFDD-3557-463B-AE3A-68A6542E14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6EFCF9-7292-4495-AE08-A5F84AD80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84E212-1471-4C9C-B78F-257F4A121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2AD34B-3B8F-4CA5-B058-C7D875C91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5561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AF5421-AAF6-4511-89AA-AF56E048CF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449EC6-CAB9-46B1-8514-279AF34392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D9AF68-D133-4858-92A0-B3C21AEA7D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DB42E0-B539-4883-B1F6-A86D098BB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D5CE6C-FD47-46B9-B836-B9053250B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0D5E92-3B49-451D-AEDC-969ACFCEA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419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DE1530-657E-468C-9F24-26688CACCA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71D5CA-15B3-4FFA-8FBD-EF47D77CFC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441923-F34C-4B6A-9155-4715D266BA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9F594-8CFD-463E-A971-D06113E637B9}" type="datetimeFigureOut">
              <a:rPr lang="en-GB" smtClean="0"/>
              <a:t>21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3BE874-CF1B-4AEF-91FA-65608E143E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A9D1A2-7E4E-4178-A720-CE963EA688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9C1BF-A7BE-48AF-BAAB-0ADDABE8CF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2427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21F483-1254-4497-A2AE-DD9D65EA8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CB1193-95B1-4422-AA91-D776F58B6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05CB6A-D727-4D63-A7E8-220E344123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1FFEE-199D-49C3-9C64-3F1476A01AF1}" type="datetimeFigureOut">
              <a:rPr lang="en-US" smtClean="0"/>
              <a:t>10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C933E5-4CC0-41F1-B0D1-A9A2EBE7DB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BAEE3A-31CE-4B95-AC24-963217E53B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97506-67DA-4633-9F63-9F6D51BF1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650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9B8FD-400E-4DFD-8145-03EA3B5C21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3999" y="1122363"/>
            <a:ext cx="9738049" cy="2387600"/>
          </a:xfrm>
        </p:spPr>
        <p:txBody>
          <a:bodyPr>
            <a:normAutofit fontScale="90000"/>
          </a:bodyPr>
          <a:lstStyle/>
          <a:p>
            <a:r>
              <a:rPr lang="en-GB" dirty="0"/>
              <a:t>Supplementary </a:t>
            </a:r>
            <a:r>
              <a:rPr lang="en-GB"/>
              <a:t>Figures </a:t>
            </a:r>
            <a:r>
              <a:rPr lang="en-GB" dirty="0"/>
              <a:t>2</a:t>
            </a:r>
            <a:r>
              <a:rPr lang="en-GB"/>
              <a:t> </a:t>
            </a:r>
            <a:r>
              <a:rPr lang="en-GB" dirty="0"/>
              <a:t>A and B</a:t>
            </a:r>
            <a:br>
              <a:rPr lang="en-GB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86FBB7-219B-4ABD-9D79-46E73A98296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 lnSpcReduction="10000"/>
          </a:bodyPr>
          <a:lstStyle/>
          <a:p>
            <a:r>
              <a:rPr lang="en-GB" dirty="0"/>
              <a:t>Manuscript: Early Access Provision: Awareness, Educational Needs and Opportunities to Improve Oncology Patients’ Access to </a:t>
            </a:r>
            <a:r>
              <a:rPr lang="en-GB"/>
              <a:t>Care </a:t>
            </a:r>
          </a:p>
          <a:p>
            <a:endParaRPr lang="en-GB" dirty="0"/>
          </a:p>
          <a:p>
            <a:r>
              <a:rPr lang="en-GB" dirty="0" err="1"/>
              <a:t>A.Krendyukov</a:t>
            </a:r>
            <a:r>
              <a:rPr lang="en-GB" dirty="0"/>
              <a:t>, </a:t>
            </a:r>
            <a:r>
              <a:rPr lang="en-GB" dirty="0" err="1"/>
              <a:t>S.Singhvi</a:t>
            </a:r>
            <a:r>
              <a:rPr lang="en-GB" dirty="0"/>
              <a:t>, </a:t>
            </a:r>
            <a:r>
              <a:rPr lang="en-US" dirty="0" err="1"/>
              <a:t>Y.Green</a:t>
            </a:r>
            <a:r>
              <a:rPr lang="en-US" dirty="0"/>
              <a:t>-Morrison, </a:t>
            </a:r>
            <a:r>
              <a:rPr lang="en-US" dirty="0" err="1"/>
              <a:t>M.Zabransky</a:t>
            </a:r>
            <a:r>
              <a:rPr lang="en-US" b="1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17883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821B51CD-74F0-469C-82D2-8D201EB024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0265802"/>
              </p:ext>
            </p:extLst>
          </p:nvPr>
        </p:nvGraphicFramePr>
        <p:xfrm>
          <a:off x="424800" y="1904400"/>
          <a:ext cx="11343600" cy="43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itle 1">
            <a:extLst>
              <a:ext uri="{FF2B5EF4-FFF2-40B4-BE49-F238E27FC236}">
                <a16:creationId xmlns:a16="http://schemas.microsoft.com/office/drawing/2014/main" id="{C61336E3-8ABD-454E-BE14-D4652BF32DAC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00" dirty="0">
                <a:effectLst/>
              </a:rPr>
              <a:t>Evaluation and rating of the</a:t>
            </a:r>
            <a:r>
              <a:rPr lang="en-US" sz="2900" dirty="0"/>
              <a:t> available </a:t>
            </a:r>
            <a:r>
              <a:rPr lang="en-US" sz="2900" dirty="0">
                <a:effectLst/>
              </a:rPr>
              <a:t>evidences to support </a:t>
            </a:r>
            <a:r>
              <a:rPr lang="en-US" sz="2900" dirty="0"/>
              <a:t>practicing physician</a:t>
            </a:r>
            <a:r>
              <a:rPr lang="en-US" sz="2900" dirty="0">
                <a:effectLst/>
              </a:rPr>
              <a:t> decision to request innovative medicinal product under early access provisions application - Europe</a:t>
            </a:r>
            <a:endParaRPr lang="en-GB" sz="2900" dirty="0"/>
          </a:p>
        </p:txBody>
      </p:sp>
    </p:spTree>
    <p:extLst>
      <p:ext uri="{BB962C8B-B14F-4D97-AF65-F5344CB8AC3E}">
        <p14:creationId xmlns:p14="http://schemas.microsoft.com/office/powerpoint/2010/main" val="2724611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E4FB65E8-04F6-416D-974F-AD0526FABD98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6000" dirty="0">
                <a:effectLst/>
              </a:rPr>
              <a:t>Evaluation and rating of the</a:t>
            </a:r>
            <a:r>
              <a:rPr lang="en-US" sz="6000" dirty="0"/>
              <a:t> available </a:t>
            </a:r>
            <a:r>
              <a:rPr lang="en-US" sz="6000" dirty="0">
                <a:effectLst/>
              </a:rPr>
              <a:t>evidences to support </a:t>
            </a:r>
            <a:r>
              <a:rPr lang="en-US" sz="6000" dirty="0"/>
              <a:t>practicing physician</a:t>
            </a:r>
            <a:r>
              <a:rPr lang="en-US" sz="6000" dirty="0">
                <a:effectLst/>
              </a:rPr>
              <a:t> decision to request innovative medicinal product under early access provisions application</a:t>
            </a:r>
            <a:r>
              <a:rPr lang="en-US" sz="6600" dirty="0">
                <a:effectLst/>
              </a:rPr>
              <a:t> - North America</a:t>
            </a:r>
            <a:endParaRPr lang="en-GB" dirty="0"/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36C3E24C-B922-4A2B-8A8F-E7283FED5F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6529961"/>
              </p:ext>
            </p:extLst>
          </p:nvPr>
        </p:nvGraphicFramePr>
        <p:xfrm>
          <a:off x="425042" y="1903535"/>
          <a:ext cx="11341915" cy="43965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902014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Custom 1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00FF81"/>
      </a:accent1>
      <a:accent2>
        <a:srgbClr val="08CFEE"/>
      </a:accent2>
      <a:accent3>
        <a:srgbClr val="FFEC00"/>
      </a:accent3>
      <a:accent4>
        <a:srgbClr val="FB90FF"/>
      </a:accent4>
      <a:accent5>
        <a:srgbClr val="FF8300"/>
      </a:accent5>
      <a:accent6>
        <a:srgbClr val="73FBFF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</TotalTime>
  <Words>91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1_Office Theme</vt:lpstr>
      <vt:lpstr>Supplementary Figures 2 A and B 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a Bakowska</dc:creator>
  <cp:lastModifiedBy>Andriy Andriy</cp:lastModifiedBy>
  <cp:revision>4</cp:revision>
  <dcterms:created xsi:type="dcterms:W3CDTF">2022-08-26T10:24:25Z</dcterms:created>
  <dcterms:modified xsi:type="dcterms:W3CDTF">2022-10-21T08:39:27Z</dcterms:modified>
</cp:coreProperties>
</file>